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60520" y="1142640"/>
            <a:ext cx="21369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CBD905-A858-4434-A774-6CF86DD6A0AE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360520" y="1143000"/>
            <a:ext cx="2136960" cy="308628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슬라이드 번호 개체 틀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D6CF01-4F33-4916-B672-6F6D3D077A5E}" type="slidenum">
              <a:rPr b="0" lang="ko-KR" sz="1200" spc="-1" strike="noStrike">
                <a:solidFill>
                  <a:srgbClr val="000000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10FAC-B14B-4A84-B41B-0A708DB7E8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1DBA8-89CF-4DF5-A0F1-5639B46AB4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81F96-9B67-4EBD-85C0-91EC6C0BD1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0AA4B-8084-4E0B-8222-5F097A2EBB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9AEF0-222C-4118-AD26-902EC4BB57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2B511-8386-414A-91DD-FCA66F0512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C34D4-C240-407E-BA4D-EC68233643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B6DFC-287E-43FE-8FDD-53F5353662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D7640-FD9B-4DBB-8085-F8751CE819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D1DDC-90FB-4E83-A5FC-8E7D276C5A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0521C-005B-4D15-88CE-8F36CA7218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D64C3-3E96-46F6-BE88-454BBB51A4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4F418A-2D71-4177-84F4-2165F68809DF}" type="slidenum">
              <a:rPr b="0" lang="ko-KR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그림 6" descr=""/>
          <p:cNvPicPr/>
          <p:nvPr/>
        </p:nvPicPr>
        <p:blipFill>
          <a:blip r:embed="rId1"/>
          <a:stretch/>
        </p:blipFill>
        <p:spPr>
          <a:xfrm>
            <a:off x="0" y="639720"/>
            <a:ext cx="6858000" cy="7415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1"/>
          <p:cNvSpPr/>
          <p:nvPr/>
        </p:nvSpPr>
        <p:spPr>
          <a:xfrm>
            <a:off x="182520" y="8151840"/>
            <a:ext cx="65134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1" lang="ko-KR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 S1. Correlation of MYC, BCL2 and BCL6 IHC score.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rrelations between MYC and BCL2 (left upper), MYC and BCL6 (right upper), and BCL2 and BCL6 (lower) IHC score was compared using Spearman correlation test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21T14:11:30Z</dcterms:created>
  <dc:creator>YOUNGHOON KIM</dc:creator>
  <dc:description/>
  <dc:language>en-US</dc:language>
  <cp:lastModifiedBy>SNUH</cp:lastModifiedBy>
  <dcterms:modified xsi:type="dcterms:W3CDTF">2015-10-08T12:43:22Z</dcterms:modified>
  <cp:revision>7</cp:revision>
  <dc:subject/>
  <dc:title>PowerPoint 프레젠테이션</dc:title>
</cp:coreProperties>
</file>